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20714"/>
            <a:ext cx="691276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ddu et al (2025) Diabetologia DOI 10.1007/s00125-025-06450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Life course of metabolic diseases in young people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74354D5-E95D-CD18-54DF-00B36A52C2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4898" y="824912"/>
            <a:ext cx="8074205" cy="4980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805264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pt-BR" dirty="0"/>
              <a:t>Boddu et al (2025) Diabetologia DOI 10.1007/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00125-025-06450-2</a:t>
            </a:r>
            <a:endParaRPr lang="pt-BR" dirty="0"/>
          </a:p>
          <a:p>
            <a:r>
              <a:rPr lang="en-GB" sz="1200" dirty="0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Reproduced from the IDF diabetes atlas, 10th edition (https://diabetesatlas.org/) under the terms of the CC BY-NC-ND 4.0 licence (https://creativecommons.org/licenses/by-nc-nd/4.0/)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ncidence of type 2 diabetes in youth ranked by region and ethnicity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122F932-D71A-C153-AA28-718A4CD3D1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0408" y="764704"/>
            <a:ext cx="3683185" cy="515646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97713"/>
            <a:ext cx="64745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pt-BR" dirty="0"/>
              <a:t>Boddu et al (2025) Diabetologia DOI 10.1007/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00125-025-06450-2</a:t>
            </a:r>
            <a:endParaRPr lang="pt-BR" dirty="0"/>
          </a:p>
          <a:p>
            <a:r>
              <a:rPr lang="en-US" sz="1200" dirty="0"/>
              <a:t>Reproduced from </a:t>
            </a:r>
            <a:r>
              <a:rPr lang="en-US" sz="1200" dirty="0" err="1"/>
              <a:t>Hormazábal</a:t>
            </a:r>
            <a:r>
              <a:rPr lang="en-US" sz="1200" dirty="0"/>
              <a:t>‐Aguayo et al (https://doi.org/10.1002/dmrr.3749) under the terms of the CC BY-NC-ND 4.0 </a:t>
            </a:r>
            <a:r>
              <a:rPr lang="en-US" sz="1200" dirty="0" err="1"/>
              <a:t>licence</a:t>
            </a:r>
            <a:r>
              <a:rPr lang="en-US" sz="1200" dirty="0"/>
              <a:t> (https://creativecommons.org/licenses/by-nc-nd/4.0/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ncidence of type 1 diabetes in youth between 2000 and 2022 ranked by region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12E4865-A555-103D-08BF-0B46BC3AF2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6327" y="1095255"/>
            <a:ext cx="6731346" cy="4667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792C72F-9005-CCCC-3604-F94FA83A8DD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91CD4B6-35B8-DC86-45B5-C97F92AF62F6}"/>
              </a:ext>
            </a:extLst>
          </p:cNvPr>
          <p:cNvSpPr txBox="1"/>
          <p:nvPr/>
        </p:nvSpPr>
        <p:spPr>
          <a:xfrm>
            <a:off x="107504" y="5797713"/>
            <a:ext cx="64745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ddu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50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54DE37-6EF5-CD47-1EE7-B553582AE3F0}"/>
              </a:ext>
            </a:extLst>
          </p:cNvPr>
          <p:cNvSpPr txBox="1"/>
          <p:nvPr/>
        </p:nvSpPr>
        <p:spPr>
          <a:xfrm>
            <a:off x="395536" y="332656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trategies to reduce the burden of youth-onset metabolic diseases</a:t>
            </a:r>
            <a:endParaRPr lang="en-GB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7C39FFB8-F7C1-EF0E-62A5-2A0865412AC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4FFD61D-14B4-CCCD-2E95-138100E485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7788" y="1261410"/>
            <a:ext cx="8388424" cy="42558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7740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6</Words>
  <Application>Microsoft Office PowerPoint</Application>
  <PresentationFormat>On-screen Show (4:3)</PresentationFormat>
  <Paragraphs>1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9</cp:revision>
  <dcterms:created xsi:type="dcterms:W3CDTF">2016-06-15T12:53:43Z</dcterms:created>
  <dcterms:modified xsi:type="dcterms:W3CDTF">2025-05-12T07:21:25Z</dcterms:modified>
</cp:coreProperties>
</file>